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9" d="100"/>
          <a:sy n="49" d="100"/>
        </p:scale>
        <p:origin x="716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0C7DD0-9275-4D79-825A-0C324A7B902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1D2D05C-EC34-4211-A486-C757DC2C8D0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39E75D-C884-4D96-AE46-03C1D199DB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B3C36-9C1E-4ED8-9624-957D0E6E68CF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FCABAB-AA84-4828-BF7B-206FBF24FE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C08BCB-D8F6-4900-B562-4DE7CC551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8B0C-EB07-4199-9F8C-90045AABC9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710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D91600-D112-4190-B3BD-F3412FFF27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F53ABC-E13D-4A5A-8C1B-29373C635F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7D6AF8-0A42-44C9-9777-DE62B467BC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B3C36-9C1E-4ED8-9624-957D0E6E68CF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2A0C4F-E682-488A-BB5A-50ED31F2E4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D409C3-BBAC-42B8-A988-6CBF68BAFF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8B0C-EB07-4199-9F8C-90045AABC9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10724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24B1E87-B128-40EA-91B3-2D4609CF40B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2B96303-1FCD-4B38-B5ED-60B25905CA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ECD6D1-9728-40E1-A6F2-906FF887BE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B3C36-9C1E-4ED8-9624-957D0E6E68CF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CB914B-F614-4142-882B-FEB361B44C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018778-5204-4ACD-8BFC-89686807E3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8B0C-EB07-4199-9F8C-90045AABC9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7946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223140-E3D2-4792-9447-5DA1CAA39E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F827A7-B455-4D2B-AA64-1EF77F76FC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348915-DDEC-42D2-B0FA-56FED61690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B3C36-9C1E-4ED8-9624-957D0E6E68CF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E44125-BA73-46EC-A224-F65FFCCE49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C6DE04-67D7-48D6-9DCF-8761274D6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8B0C-EB07-4199-9F8C-90045AABC9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292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56387D-DA2C-44FC-8E76-685E7E72BF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7129EC-A6E7-40C2-BC32-CF2A325991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F95081-38F6-4F32-84AF-23F8442691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B3C36-9C1E-4ED8-9624-957D0E6E68CF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B49CF4-2771-408E-8EF7-B9F9456E6C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437B2C-33A5-4F20-8B4B-5AEB853742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8B0C-EB07-4199-9F8C-90045AABC9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32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C682DD-1896-44E6-9F9F-4E2AEEE0D9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0B60C2-2863-4CE8-BFC2-81B5BC2D30D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BE05448-A4D9-4011-9119-4EA243ABFF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E003FC-FE7C-4CE1-84F4-CDA4F6B16B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B3C36-9C1E-4ED8-9624-957D0E6E68CF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B1EAE7-75ED-4028-90FB-10FFE08BCB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19A354-73CE-44E5-8203-FD8E8F2D2E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8B0C-EB07-4199-9F8C-90045AABC9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547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9BBED9-C511-43CB-8831-F11B5E136B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3A15CC-081D-420C-BB4E-898B2DC4AE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2CE7BA5-B502-4112-8B77-2B5D858827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8B58C62-7DC4-41C2-B11E-1CFADDEC70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15D54B7-2C18-4037-A6D1-5926B1AB00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C0DA4E4-F8BC-44E4-825F-A7D6813204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B3C36-9C1E-4ED8-9624-957D0E6E68CF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9252B4F-2800-48DF-8FE8-B42FD88633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C30EEE9-F947-45E3-9919-7D5A290935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8B0C-EB07-4199-9F8C-90045AABC9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50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57FA34-C9CA-49CA-BE4C-023C438BA4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C47C418-1FF1-455B-B97B-69E9520C25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B3C36-9C1E-4ED8-9624-957D0E6E68CF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766030F-5E8E-491F-8480-F93B420D9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386437-FFAC-494F-9D0F-89CD2EDC9F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8B0C-EB07-4199-9F8C-90045AABC9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685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285379-1817-4128-AB78-C8F9BA221A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B3C36-9C1E-4ED8-9624-957D0E6E68CF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9304571-9587-4F46-81E5-BCFB1E9E06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0C32A9D-71A5-4AC5-9022-B7536DC90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8B0C-EB07-4199-9F8C-90045AABC9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990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54C103-3ABD-42CA-A578-744BEAAF16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4E8BAD-7F5A-4A41-8200-A5DE7E7A652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54D933-12C0-4C37-B0C4-88589FEA95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FC4F7B-5257-41DA-8534-F1D2C6CE97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B3C36-9C1E-4ED8-9624-957D0E6E68CF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D1CFCF-0343-4E69-A40B-A744EC1C42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5EC642-EC41-426A-967B-25174EF3AD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8B0C-EB07-4199-9F8C-90045AABC9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303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432D0C-6715-4617-AAF9-B5C3EE8D58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FA8751C-81AD-4559-A56F-4A9FEFFC28D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949E05-D688-45C2-9437-B542C22D87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5B8FD6-5F44-4CC5-A7DF-FE5D548B56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B3C36-9C1E-4ED8-9624-957D0E6E68CF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FBD006-8FB1-47FC-8D81-A44C72C2F5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DCE7F4-5E5A-43DB-BB00-18CEC8C44C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8B0C-EB07-4199-9F8C-90045AABC9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15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7E74F06-62F7-4A3A-AD6C-5F8BA34426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744AC3-7450-49AA-AACD-E2D8D2A397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CA6292-6743-4CA2-BE71-EB5C217877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DB3C36-9C1E-4ED8-9624-957D0E6E68CF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AEE8E4-1256-406E-9A47-3A92128901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73113C-8AED-4080-B0FA-046F3B8147B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078B0C-EB07-4199-9F8C-90045AABC9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947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17BB961A-6AB7-4084-A0E8-4AB8E97ABF0E}"/>
              </a:ext>
            </a:extLst>
          </p:cNvPr>
          <p:cNvGrpSpPr/>
          <p:nvPr/>
        </p:nvGrpSpPr>
        <p:grpSpPr>
          <a:xfrm>
            <a:off x="3068320" y="85121"/>
            <a:ext cx="5892800" cy="5584159"/>
            <a:chOff x="0" y="434906"/>
            <a:chExt cx="6551269" cy="6276791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9DFDC7D-D932-4CA1-8B0E-9CEA7A6CBD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347" r="16096" b="4214"/>
            <a:stretch/>
          </p:blipFill>
          <p:spPr>
            <a:xfrm>
              <a:off x="152399" y="681124"/>
              <a:ext cx="4624753" cy="5187673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4080B3B-D445-46CA-A35F-7B695C5D5EA2}"/>
                </a:ext>
              </a:extLst>
            </p:cNvPr>
            <p:cNvSpPr txBox="1"/>
            <p:nvPr/>
          </p:nvSpPr>
          <p:spPr>
            <a:xfrm rot="18848743">
              <a:off x="-325292" y="6078628"/>
              <a:ext cx="9583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/>
                <a:t>QC-1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B8D232E-FA84-4E1B-AA7C-24E63FC37D47}"/>
                </a:ext>
              </a:extLst>
            </p:cNvPr>
            <p:cNvSpPr txBox="1"/>
            <p:nvPr/>
          </p:nvSpPr>
          <p:spPr>
            <a:xfrm rot="18848743">
              <a:off x="182011" y="6078628"/>
              <a:ext cx="9583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/>
                <a:t>QC-2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7F9CFA4-C985-435B-8D07-86FAC3AED2E1}"/>
                </a:ext>
              </a:extLst>
            </p:cNvPr>
            <p:cNvSpPr txBox="1"/>
            <p:nvPr/>
          </p:nvSpPr>
          <p:spPr>
            <a:xfrm rot="18848743">
              <a:off x="689313" y="6078628"/>
              <a:ext cx="9583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/>
                <a:t>QC-3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4A42E0D-2BCE-4CB6-995B-51A8BABCCC46}"/>
                </a:ext>
              </a:extLst>
            </p:cNvPr>
            <p:cNvSpPr txBox="1"/>
            <p:nvPr/>
          </p:nvSpPr>
          <p:spPr>
            <a:xfrm rot="18848743">
              <a:off x="1196619" y="6078627"/>
              <a:ext cx="9583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/>
                <a:t>M-HL-1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FD450C8-6033-472D-B164-A4BD7FABB12D}"/>
                </a:ext>
              </a:extLst>
            </p:cNvPr>
            <p:cNvSpPr txBox="1"/>
            <p:nvPr/>
          </p:nvSpPr>
          <p:spPr>
            <a:xfrm rot="18848743">
              <a:off x="1703920" y="6078627"/>
              <a:ext cx="9583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/>
                <a:t>M-HL-2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F9C172C-8A9E-46F6-AC81-EB84C52F3E9B}"/>
                </a:ext>
              </a:extLst>
            </p:cNvPr>
            <p:cNvSpPr txBox="1"/>
            <p:nvPr/>
          </p:nvSpPr>
          <p:spPr>
            <a:xfrm rot="18848743">
              <a:off x="2211223" y="6078627"/>
              <a:ext cx="9583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/>
                <a:t>M-HL-3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B38CC2E-BCD3-4BC1-9223-DFBC602185B7}"/>
                </a:ext>
              </a:extLst>
            </p:cNvPr>
            <p:cNvSpPr txBox="1"/>
            <p:nvPr/>
          </p:nvSpPr>
          <p:spPr>
            <a:xfrm rot="18848743">
              <a:off x="2718525" y="6078627"/>
              <a:ext cx="9583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/>
                <a:t>SCV-IL-1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8FF473B-510E-43B9-986E-3E2C7831AB04}"/>
                </a:ext>
              </a:extLst>
            </p:cNvPr>
            <p:cNvSpPr txBox="1"/>
            <p:nvPr/>
          </p:nvSpPr>
          <p:spPr>
            <a:xfrm rot="18848743">
              <a:off x="3225829" y="6078627"/>
              <a:ext cx="9583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/>
                <a:t>SCV-IL-2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90E20E6-298C-480E-868F-7A56DAC3E7C8}"/>
                </a:ext>
              </a:extLst>
            </p:cNvPr>
            <p:cNvSpPr txBox="1"/>
            <p:nvPr/>
          </p:nvSpPr>
          <p:spPr>
            <a:xfrm rot="18848743">
              <a:off x="3733135" y="6078627"/>
              <a:ext cx="9583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/>
                <a:t>SCV-IL-3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FE46B26-175B-4A21-9EB4-B57C3304C00A}"/>
                </a:ext>
              </a:extLst>
            </p:cNvPr>
            <p:cNvSpPr txBox="1"/>
            <p:nvPr/>
          </p:nvSpPr>
          <p:spPr>
            <a:xfrm>
              <a:off x="4765577" y="967455"/>
              <a:ext cx="1601159" cy="4901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547"/>
                </a:lnSpc>
              </a:pPr>
              <a:r>
                <a:rPr lang="en-US" sz="1400" b="1" dirty="0"/>
                <a:t>QC-1</a:t>
              </a:r>
            </a:p>
            <a:p>
              <a:pPr>
                <a:lnSpc>
                  <a:spcPts val="1547"/>
                </a:lnSpc>
              </a:pPr>
              <a:endParaRPr lang="en-US" sz="1400" b="1" dirty="0"/>
            </a:p>
            <a:p>
              <a:pPr>
                <a:lnSpc>
                  <a:spcPts val="1547"/>
                </a:lnSpc>
              </a:pPr>
              <a:endParaRPr lang="en-US" sz="1400" b="1" dirty="0"/>
            </a:p>
            <a:p>
              <a:pPr>
                <a:lnSpc>
                  <a:spcPts val="1547"/>
                </a:lnSpc>
              </a:pPr>
              <a:r>
                <a:rPr lang="en-US" sz="1400" b="1" dirty="0"/>
                <a:t>QC-2</a:t>
              </a:r>
            </a:p>
            <a:p>
              <a:pPr>
                <a:lnSpc>
                  <a:spcPts val="1547"/>
                </a:lnSpc>
              </a:pPr>
              <a:endParaRPr lang="en-US" sz="1400" b="1" dirty="0"/>
            </a:p>
            <a:p>
              <a:pPr>
                <a:lnSpc>
                  <a:spcPts val="1547"/>
                </a:lnSpc>
              </a:pPr>
              <a:endParaRPr lang="en-US" sz="1400" b="1" dirty="0"/>
            </a:p>
            <a:p>
              <a:pPr>
                <a:lnSpc>
                  <a:spcPts val="1547"/>
                </a:lnSpc>
              </a:pPr>
              <a:r>
                <a:rPr lang="en-US" sz="1400" b="1" dirty="0"/>
                <a:t>QC-3</a:t>
              </a:r>
            </a:p>
            <a:p>
              <a:pPr>
                <a:lnSpc>
                  <a:spcPts val="1547"/>
                </a:lnSpc>
              </a:pPr>
              <a:endParaRPr lang="en-US" sz="1400" b="1" dirty="0"/>
            </a:p>
            <a:p>
              <a:pPr>
                <a:lnSpc>
                  <a:spcPts val="1547"/>
                </a:lnSpc>
              </a:pPr>
              <a:endParaRPr lang="en-US" sz="1400" b="1" dirty="0"/>
            </a:p>
            <a:p>
              <a:pPr>
                <a:lnSpc>
                  <a:spcPts val="1547"/>
                </a:lnSpc>
              </a:pPr>
              <a:r>
                <a:rPr lang="en-US" sz="1400" b="1" dirty="0"/>
                <a:t>M-HL-1</a:t>
              </a:r>
            </a:p>
            <a:p>
              <a:pPr>
                <a:lnSpc>
                  <a:spcPts val="1547"/>
                </a:lnSpc>
              </a:pPr>
              <a:endParaRPr lang="en-US" sz="1400" b="1" dirty="0"/>
            </a:p>
            <a:p>
              <a:pPr>
                <a:lnSpc>
                  <a:spcPts val="1547"/>
                </a:lnSpc>
              </a:pPr>
              <a:endParaRPr lang="en-US" sz="1400" b="1" dirty="0"/>
            </a:p>
            <a:p>
              <a:pPr>
                <a:lnSpc>
                  <a:spcPts val="1547"/>
                </a:lnSpc>
              </a:pPr>
              <a:r>
                <a:rPr lang="en-US" sz="1400" b="1" dirty="0"/>
                <a:t>M-HL-2</a:t>
              </a:r>
            </a:p>
            <a:p>
              <a:pPr>
                <a:lnSpc>
                  <a:spcPts val="1547"/>
                </a:lnSpc>
              </a:pPr>
              <a:endParaRPr lang="en-US" sz="1400" b="1" dirty="0"/>
            </a:p>
            <a:p>
              <a:pPr>
                <a:lnSpc>
                  <a:spcPts val="1547"/>
                </a:lnSpc>
              </a:pPr>
              <a:endParaRPr lang="en-US" sz="1400" b="1" dirty="0"/>
            </a:p>
            <a:p>
              <a:pPr>
                <a:lnSpc>
                  <a:spcPts val="1547"/>
                </a:lnSpc>
              </a:pPr>
              <a:r>
                <a:rPr lang="en-US" sz="1400" b="1" dirty="0"/>
                <a:t>M-HL-3</a:t>
              </a:r>
            </a:p>
            <a:p>
              <a:pPr>
                <a:lnSpc>
                  <a:spcPts val="1547"/>
                </a:lnSpc>
              </a:pPr>
              <a:endParaRPr lang="en-US" sz="1400" b="1" dirty="0"/>
            </a:p>
            <a:p>
              <a:pPr>
                <a:lnSpc>
                  <a:spcPts val="1547"/>
                </a:lnSpc>
              </a:pPr>
              <a:endParaRPr lang="en-US" sz="1400" b="1" dirty="0"/>
            </a:p>
            <a:p>
              <a:pPr>
                <a:lnSpc>
                  <a:spcPts val="1547"/>
                </a:lnSpc>
              </a:pPr>
              <a:r>
                <a:rPr lang="en-US" sz="1400" b="1" dirty="0"/>
                <a:t>SCV-IL-1</a:t>
              </a:r>
            </a:p>
            <a:p>
              <a:pPr>
                <a:lnSpc>
                  <a:spcPts val="1547"/>
                </a:lnSpc>
              </a:pPr>
              <a:endParaRPr lang="en-US" sz="1400" b="1" dirty="0"/>
            </a:p>
            <a:p>
              <a:pPr>
                <a:lnSpc>
                  <a:spcPts val="1547"/>
                </a:lnSpc>
              </a:pPr>
              <a:endParaRPr lang="en-US" sz="1400" b="1" dirty="0"/>
            </a:p>
            <a:p>
              <a:pPr>
                <a:lnSpc>
                  <a:spcPts val="1547"/>
                </a:lnSpc>
              </a:pPr>
              <a:r>
                <a:rPr lang="en-US" sz="1400" b="1" dirty="0"/>
                <a:t>SCV-IL-2</a:t>
              </a:r>
            </a:p>
            <a:p>
              <a:pPr>
                <a:lnSpc>
                  <a:spcPts val="1547"/>
                </a:lnSpc>
              </a:pPr>
              <a:endParaRPr lang="en-US" sz="1400" b="1" dirty="0"/>
            </a:p>
            <a:p>
              <a:pPr>
                <a:lnSpc>
                  <a:spcPts val="1547"/>
                </a:lnSpc>
              </a:pPr>
              <a:endParaRPr lang="en-US" sz="1400" b="1" dirty="0"/>
            </a:p>
            <a:p>
              <a:pPr>
                <a:lnSpc>
                  <a:spcPts val="1547"/>
                </a:lnSpc>
              </a:pPr>
              <a:r>
                <a:rPr lang="en-US" sz="1400" b="1" dirty="0"/>
                <a:t>SCV-IL-3 </a:t>
              </a:r>
            </a:p>
          </p:txBody>
        </p:sp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8E098DF9-2298-4BA7-8C09-E4B6FF9927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538" r="5639" b="66684"/>
            <a:stretch/>
          </p:blipFill>
          <p:spPr>
            <a:xfrm>
              <a:off x="5389776" y="485013"/>
              <a:ext cx="166072" cy="1945671"/>
            </a:xfrm>
            <a:prstGeom prst="rect">
              <a:avLst/>
            </a:prstGeom>
          </p:spPr>
        </p:pic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82D5607C-1AB5-40E7-B0E4-EA6AABE42362}"/>
                </a:ext>
              </a:extLst>
            </p:cNvPr>
            <p:cNvGrpSpPr/>
            <p:nvPr/>
          </p:nvGrpSpPr>
          <p:grpSpPr>
            <a:xfrm>
              <a:off x="201785" y="446481"/>
              <a:ext cx="4563792" cy="238150"/>
              <a:chOff x="213360" y="388606"/>
              <a:chExt cx="4563792" cy="238150"/>
            </a:xfrm>
          </p:grpSpPr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A5CCE381-AF7B-4F88-B088-B6B9919B723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19" t="-620" r="89390" b="97071"/>
              <a:stretch/>
            </p:blipFill>
            <p:spPr>
              <a:xfrm>
                <a:off x="213360" y="388606"/>
                <a:ext cx="1510986" cy="229400"/>
              </a:xfrm>
              <a:prstGeom prst="rect">
                <a:avLst/>
              </a:prstGeom>
            </p:spPr>
          </p:pic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B5531226-01A7-47A7-9A42-3D24054C3B0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811" t="625" r="31704" b="96939"/>
              <a:stretch/>
            </p:blipFill>
            <p:spPr>
              <a:xfrm>
                <a:off x="3253740" y="468630"/>
                <a:ext cx="1523412" cy="158126"/>
              </a:xfrm>
              <a:prstGeom prst="rect">
                <a:avLst/>
              </a:prstGeom>
            </p:spPr>
          </p:pic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id="{ECAEA954-EF02-421B-AB93-35831DCB97F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436" r="59338" b="97025"/>
              <a:stretch/>
            </p:blipFill>
            <p:spPr>
              <a:xfrm>
                <a:off x="1724346" y="428864"/>
                <a:ext cx="1529394" cy="192952"/>
              </a:xfrm>
              <a:prstGeom prst="rect">
                <a:avLst/>
              </a:prstGeom>
            </p:spPr>
          </p:pic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C74E7F7-B727-46CB-BB54-616AE872D7EC}"/>
                </a:ext>
              </a:extLst>
            </p:cNvPr>
            <p:cNvSpPr txBox="1"/>
            <p:nvPr/>
          </p:nvSpPr>
          <p:spPr>
            <a:xfrm>
              <a:off x="5508281" y="434906"/>
              <a:ext cx="1042988" cy="17081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351"/>
                </a:lnSpc>
              </a:pPr>
              <a:r>
                <a:rPr lang="en-US" sz="1100" b="1" dirty="0"/>
                <a:t>1.00</a:t>
              </a:r>
            </a:p>
            <a:p>
              <a:pPr>
                <a:lnSpc>
                  <a:spcPts val="1351"/>
                </a:lnSpc>
              </a:pPr>
              <a:endParaRPr lang="en-US" sz="1100" b="1" dirty="0"/>
            </a:p>
            <a:p>
              <a:pPr>
                <a:lnSpc>
                  <a:spcPts val="1351"/>
                </a:lnSpc>
              </a:pPr>
              <a:r>
                <a:rPr lang="en-US" sz="1100" b="1" dirty="0"/>
                <a:t>0.99</a:t>
              </a:r>
            </a:p>
            <a:p>
              <a:pPr>
                <a:lnSpc>
                  <a:spcPts val="1351"/>
                </a:lnSpc>
              </a:pPr>
              <a:endParaRPr lang="en-US" sz="1100" b="1" dirty="0"/>
            </a:p>
            <a:p>
              <a:pPr>
                <a:lnSpc>
                  <a:spcPts val="1351"/>
                </a:lnSpc>
              </a:pPr>
              <a:r>
                <a:rPr lang="en-US" sz="1100" b="1" dirty="0"/>
                <a:t>0.98</a:t>
              </a:r>
            </a:p>
            <a:p>
              <a:pPr>
                <a:lnSpc>
                  <a:spcPts val="1351"/>
                </a:lnSpc>
              </a:pPr>
              <a:endParaRPr lang="en-US" sz="1100" b="1" dirty="0"/>
            </a:p>
            <a:p>
              <a:pPr>
                <a:lnSpc>
                  <a:spcPts val="1351"/>
                </a:lnSpc>
              </a:pPr>
              <a:r>
                <a:rPr lang="en-US" sz="1100" b="1" dirty="0"/>
                <a:t>0.97</a:t>
              </a:r>
            </a:p>
            <a:p>
              <a:pPr>
                <a:lnSpc>
                  <a:spcPts val="1351"/>
                </a:lnSpc>
              </a:pPr>
              <a:endParaRPr lang="en-US" sz="1100" b="1" dirty="0"/>
            </a:p>
            <a:p>
              <a:pPr>
                <a:lnSpc>
                  <a:spcPts val="1351"/>
                </a:lnSpc>
              </a:pPr>
              <a:r>
                <a:rPr lang="en-US" sz="1100" b="1" dirty="0"/>
                <a:t>0.96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FF3034E-A159-4864-A6CA-BA4B2AF5849F}"/>
                </a:ext>
              </a:extLst>
            </p:cNvPr>
            <p:cNvSpPr txBox="1"/>
            <p:nvPr/>
          </p:nvSpPr>
          <p:spPr>
            <a:xfrm>
              <a:off x="4759322" y="451679"/>
              <a:ext cx="7293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Group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2FD76A5-2FB5-4F9E-BE99-B08C5F0C909E}"/>
                </a:ext>
              </a:extLst>
            </p:cNvPr>
            <p:cNvSpPr txBox="1"/>
            <p:nvPr/>
          </p:nvSpPr>
          <p:spPr>
            <a:xfrm>
              <a:off x="754807" y="474829"/>
              <a:ext cx="43208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/>
                <a:t>QC                                            M-HL                                  SCV-IL</a:t>
              </a:r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21B83BEC-85FC-41D8-914F-58715C90E428}"/>
              </a:ext>
            </a:extLst>
          </p:cNvPr>
          <p:cNvSpPr txBox="1"/>
          <p:nvPr/>
        </p:nvSpPr>
        <p:spPr>
          <a:xfrm>
            <a:off x="2169160" y="5553462"/>
            <a:ext cx="781812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S1 Fig. A clustered heatmap of pairwise Pearson’s correlation coefficients of the metabolites from three replicates of mock healthy leaf (M-HL) and SCV phytoplasma-infected leaf (SCV-IL), and quality control (QC) samples of sweet cherry trees.</a:t>
            </a:r>
            <a:r>
              <a:rPr lang="en-US" sz="1600" dirty="0"/>
              <a:t> Color key scale is shown on the right of the heatmap. </a:t>
            </a:r>
          </a:p>
        </p:txBody>
      </p:sp>
    </p:spTree>
    <p:extLst>
      <p:ext uri="{BB962C8B-B14F-4D97-AF65-F5344CB8AC3E}">
        <p14:creationId xmlns:p14="http://schemas.microsoft.com/office/powerpoint/2010/main" val="11113970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2</Words>
  <Application>Microsoft Office PowerPoint</Application>
  <PresentationFormat>Widescreen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i, Wei</dc:creator>
  <cp:lastModifiedBy>Wei, Wei</cp:lastModifiedBy>
  <cp:revision>2</cp:revision>
  <dcterms:created xsi:type="dcterms:W3CDTF">2020-11-11T01:09:53Z</dcterms:created>
  <dcterms:modified xsi:type="dcterms:W3CDTF">2020-12-23T20:46:44Z</dcterms:modified>
</cp:coreProperties>
</file>